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FA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4B715-B8CC-5D6C-2258-2EC824D909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E733F5-DCF5-4DAA-0A24-3B069452D0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2D153B-7EB0-4FAA-23AC-E5BF74355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F44C86-5DB6-3EB6-A654-9BB3AF08B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7804A0-8F0E-C7B4-44BD-A78C18B0F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252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125991-DB92-2EDB-3C59-521A25C7B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187415-B474-104A-5F39-67004C73D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AA040-4F7A-9F83-1B4F-4CC5AE8A2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75A02-E2B0-9437-D69C-3189F50D0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FAD1DB-B59C-72D2-7408-1BAF2ECA4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864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FFEA49-A25E-F2C6-697B-67D89C2C62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5B5560-3293-C3B1-4461-649DF51EB2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AD4B90-6B2F-150D-45D7-888FFB634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073DB6-EC8B-D140-EDAE-C4084EC3D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C6452-14A2-1004-BDDF-18F819C3A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42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B2604F-FA97-E29D-D1C8-2C72BC769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09135F-F092-1400-0EA5-B653958CEC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D7BF1-2943-97C8-84A1-C655487F0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033383-BB4A-D71F-7F5C-5FF545BCB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99C46B-FE9E-B88B-A831-94A29E9DB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553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AE3F6-E0A5-1A9D-77D9-DD96EB6AF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495182-9CA6-48A5-F973-1023F2F93B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401AA0-897D-E51D-32B2-6CAFE5004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A7F4F-D110-5CF5-1EEA-8666678BF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121AB9-1BE2-DF3C-9AA9-B8C5567D3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514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7FA158-8A88-1BC6-A8EA-7EEC0F7CE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EB333A-DA3D-03AC-DBB6-4F56A83B9B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2459CA-47AC-485C-85C5-084176EB9D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DC5C5B-0240-57E4-8B11-320B0E985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9CAA39-02EA-BCDB-AF7F-C6BC0C3FE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EBE453-B866-1640-E64C-5B12A8037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583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2F1E4-4FE6-FDE4-2A36-688C60005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3E4EEF-CBF9-A332-8668-29254A70A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A90628-8EE7-D577-95AE-E7F231B035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47FF42-2A72-66F8-0241-C2EA7B5ABA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7B2A115-43A6-A469-5DB3-F09F505FB6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44EC0D-1F04-C922-40EE-503C46BFE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3FE5BD-1111-3331-D9F4-1FEB5578C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9A230C-0790-916A-7B40-4A32EC50F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039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36EB8-EA91-6FFC-6F7B-DA590828D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B7FB40-51BD-FDB6-C54D-C947496CA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37FB1B-DCB7-70EC-D276-6FA5DDC1D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2BE3C8-4CA5-1181-3321-9EA49C110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777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8EB3D2-AC27-D765-C8D2-9B520242C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D7BB32-7953-4D7A-E14C-7047978E7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F3E615-CFD3-F13D-0CBE-E4571D936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90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E4989-0E66-604E-3FA0-DCB82B277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26770E-4AA9-3AC7-28B5-F85BE315C3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353743-F1A1-EAC9-71AD-9BEDD903DE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04AA79-B1FF-21D3-497F-7605C7209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0814A1-071A-06F8-F595-FB47C3DB6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DB70FB-A690-8786-DB24-E89B807D8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650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E6D15-75B0-D003-F80D-C11F0EF7B0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B10BA0-D2BE-E654-4AAF-929A6FD664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B14408-2535-9706-0926-AFF443916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A68F31-B839-E15C-2488-948C062BF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5BA020-6815-6341-07F0-486A39EB6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EB4EF5-D7C9-2282-B70C-5AB9804DD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440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234252-8E36-929F-01F3-680F0DE8B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520D98-4073-44DC-FB36-2C8D4EB212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7D439B-B151-487C-8B45-A0103CC518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4482F-A745-9249-80D1-E1861E066633}" type="datetimeFigureOut">
              <a:rPr lang="en-US" smtClean="0"/>
              <a:t>3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00B9DF-D05F-14D4-3C00-DC03F9BBA8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5ADC9-6001-061A-BD73-AF2EB88680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54A543-39BF-1C42-8D68-A85945A18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48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8EA21-4E67-0BAD-D4E7-E0880F30CDA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Genome clustering supplements</a:t>
            </a:r>
          </a:p>
        </p:txBody>
      </p:sp>
    </p:spTree>
    <p:extLst>
      <p:ext uri="{BB962C8B-B14F-4D97-AF65-F5344CB8AC3E}">
        <p14:creationId xmlns:p14="http://schemas.microsoft.com/office/powerpoint/2010/main" val="3300448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F1E05-4CC9-DF54-CB6B-72E5CEDCF4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69992"/>
          </a:xfrm>
        </p:spPr>
        <p:txBody>
          <a:bodyPr>
            <a:normAutofit/>
          </a:bodyPr>
          <a:lstStyle/>
          <a:p>
            <a:r>
              <a:rPr lang="en-US" sz="3600" dirty="0"/>
              <a:t>RNase MRP-based clustering for fungi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B66A204-9374-8C27-4368-385D89550A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956918"/>
              </p:ext>
            </p:extLst>
          </p:nvPr>
        </p:nvGraphicFramePr>
        <p:xfrm>
          <a:off x="3449581" y="2165065"/>
          <a:ext cx="8549381" cy="3053080"/>
        </p:xfrm>
        <a:graphic>
          <a:graphicData uri="http://schemas.openxmlformats.org/drawingml/2006/table">
            <a:tbl>
              <a:tblPr/>
              <a:tblGrid>
                <a:gridCol w="971250">
                  <a:extLst>
                    <a:ext uri="{9D8B030D-6E8A-4147-A177-3AD203B41FA5}">
                      <a16:colId xmlns:a16="http://schemas.microsoft.com/office/drawing/2014/main" val="395890671"/>
                    </a:ext>
                  </a:extLst>
                </a:gridCol>
                <a:gridCol w="784718">
                  <a:extLst>
                    <a:ext uri="{9D8B030D-6E8A-4147-A177-3AD203B41FA5}">
                      <a16:colId xmlns:a16="http://schemas.microsoft.com/office/drawing/2014/main" val="2808126701"/>
                    </a:ext>
                  </a:extLst>
                </a:gridCol>
                <a:gridCol w="662278">
                  <a:extLst>
                    <a:ext uri="{9D8B030D-6E8A-4147-A177-3AD203B41FA5}">
                      <a16:colId xmlns:a16="http://schemas.microsoft.com/office/drawing/2014/main" val="3278938468"/>
                    </a:ext>
                  </a:extLst>
                </a:gridCol>
                <a:gridCol w="803065">
                  <a:extLst>
                    <a:ext uri="{9D8B030D-6E8A-4147-A177-3AD203B41FA5}">
                      <a16:colId xmlns:a16="http://schemas.microsoft.com/office/drawing/2014/main" val="3368696708"/>
                    </a:ext>
                  </a:extLst>
                </a:gridCol>
                <a:gridCol w="803065">
                  <a:extLst>
                    <a:ext uri="{9D8B030D-6E8A-4147-A177-3AD203B41FA5}">
                      <a16:colId xmlns:a16="http://schemas.microsoft.com/office/drawing/2014/main" val="1406836836"/>
                    </a:ext>
                  </a:extLst>
                </a:gridCol>
                <a:gridCol w="803065">
                  <a:extLst>
                    <a:ext uri="{9D8B030D-6E8A-4147-A177-3AD203B41FA5}">
                      <a16:colId xmlns:a16="http://schemas.microsoft.com/office/drawing/2014/main" val="972800478"/>
                    </a:ext>
                  </a:extLst>
                </a:gridCol>
                <a:gridCol w="692533">
                  <a:extLst>
                    <a:ext uri="{9D8B030D-6E8A-4147-A177-3AD203B41FA5}">
                      <a16:colId xmlns:a16="http://schemas.microsoft.com/office/drawing/2014/main" val="1961516807"/>
                    </a:ext>
                  </a:extLst>
                </a:gridCol>
                <a:gridCol w="718434">
                  <a:extLst>
                    <a:ext uri="{9D8B030D-6E8A-4147-A177-3AD203B41FA5}">
                      <a16:colId xmlns:a16="http://schemas.microsoft.com/office/drawing/2014/main" val="923984602"/>
                    </a:ext>
                  </a:extLst>
                </a:gridCol>
                <a:gridCol w="658566">
                  <a:extLst>
                    <a:ext uri="{9D8B030D-6E8A-4147-A177-3AD203B41FA5}">
                      <a16:colId xmlns:a16="http://schemas.microsoft.com/office/drawing/2014/main" val="1531034175"/>
                    </a:ext>
                  </a:extLst>
                </a:gridCol>
                <a:gridCol w="886077">
                  <a:extLst>
                    <a:ext uri="{9D8B030D-6E8A-4147-A177-3AD203B41FA5}">
                      <a16:colId xmlns:a16="http://schemas.microsoft.com/office/drawing/2014/main" val="2635345302"/>
                    </a:ext>
                  </a:extLst>
                </a:gridCol>
                <a:gridCol w="766330">
                  <a:extLst>
                    <a:ext uri="{9D8B030D-6E8A-4147-A177-3AD203B41FA5}">
                      <a16:colId xmlns:a16="http://schemas.microsoft.com/office/drawing/2014/main" val="1784235134"/>
                    </a:ext>
                  </a:extLst>
                </a:gridCol>
              </a:tblGrid>
              <a:tr h="820720"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RNase MRP avgid for clustering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# clusters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DB size (G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1 time (s) 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97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1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97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2 time (s) 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2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3 </a:t>
                      </a:r>
                    </a:p>
                    <a:p>
                      <a:r>
                        <a:rPr lang="en-US" sz="1050" b="1" dirty="0">
                          <a:effectLst/>
                        </a:rPr>
                        <a:t>time </a:t>
                      </a:r>
                    </a:p>
                    <a:p>
                      <a:r>
                        <a:rPr lang="en-US" sz="1050" b="1" dirty="0">
                          <a:effectLst/>
                        </a:rPr>
                        <a:t>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19D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U3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19D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GLY1 flanked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2BF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dirty="0">
                          <a:effectLst/>
                        </a:rPr>
                        <a:t>GLY1 flanked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2BF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8634000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5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>
                          <a:effectLst/>
                        </a:rPr>
                        <a:t>8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.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0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8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3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5477662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5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9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48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83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13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36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9069671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15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4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44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11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12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4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849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7879470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21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8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95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417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43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298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9047288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>
                          <a:effectLst/>
                        </a:rPr>
                        <a:t>7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08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2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428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845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951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0910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3157310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>
                          <a:effectLst/>
                        </a:rPr>
                        <a:t>7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57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5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998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163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115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4190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4252574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8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92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6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080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342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246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7781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2953296"/>
                  </a:ext>
                </a:extLst>
              </a:tr>
              <a:tr h="279045"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00 (all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620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6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446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183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3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013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7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21658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effectLst/>
                        </a:rPr>
                        <a:t>1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1323591"/>
                  </a:ext>
                </a:extLst>
              </a:tr>
            </a:tbl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BD248FE8-36E2-C08D-222A-C895E6E62F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39" y="1443202"/>
            <a:ext cx="3224226" cy="4537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7606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13E6D5-872F-A9B8-E5B8-09B6E080B3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B10F4-0241-E2FC-9850-A8D776B77C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69992"/>
          </a:xfrm>
        </p:spPr>
        <p:txBody>
          <a:bodyPr>
            <a:normAutofit/>
          </a:bodyPr>
          <a:lstStyle/>
          <a:p>
            <a:r>
              <a:rPr lang="en-US" sz="3600" dirty="0"/>
              <a:t>RNase MRP-based clustering for plant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F002F29-A750-6965-F39E-85C98A686A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483" y="1413860"/>
            <a:ext cx="3861798" cy="4913367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690F6A1-F38D-3D6B-8D89-F9E94F102A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7730495"/>
              </p:ext>
            </p:extLst>
          </p:nvPr>
        </p:nvGraphicFramePr>
        <p:xfrm>
          <a:off x="4307837" y="2329814"/>
          <a:ext cx="7487922" cy="3115943"/>
        </p:xfrm>
        <a:graphic>
          <a:graphicData uri="http://schemas.openxmlformats.org/drawingml/2006/table">
            <a:tbl>
              <a:tblPr/>
              <a:tblGrid>
                <a:gridCol w="971019">
                  <a:extLst>
                    <a:ext uri="{9D8B030D-6E8A-4147-A177-3AD203B41FA5}">
                      <a16:colId xmlns:a16="http://schemas.microsoft.com/office/drawing/2014/main" val="1443994622"/>
                    </a:ext>
                  </a:extLst>
                </a:gridCol>
                <a:gridCol w="757218">
                  <a:extLst>
                    <a:ext uri="{9D8B030D-6E8A-4147-A177-3AD203B41FA5}">
                      <a16:colId xmlns:a16="http://schemas.microsoft.com/office/drawing/2014/main" val="2469015909"/>
                    </a:ext>
                  </a:extLst>
                </a:gridCol>
                <a:gridCol w="873026">
                  <a:extLst>
                    <a:ext uri="{9D8B030D-6E8A-4147-A177-3AD203B41FA5}">
                      <a16:colId xmlns:a16="http://schemas.microsoft.com/office/drawing/2014/main" val="2137586762"/>
                    </a:ext>
                  </a:extLst>
                </a:gridCol>
                <a:gridCol w="873026">
                  <a:extLst>
                    <a:ext uri="{9D8B030D-6E8A-4147-A177-3AD203B41FA5}">
                      <a16:colId xmlns:a16="http://schemas.microsoft.com/office/drawing/2014/main" val="2224683362"/>
                    </a:ext>
                  </a:extLst>
                </a:gridCol>
                <a:gridCol w="605192">
                  <a:extLst>
                    <a:ext uri="{9D8B030D-6E8A-4147-A177-3AD203B41FA5}">
                      <a16:colId xmlns:a16="http://schemas.microsoft.com/office/drawing/2014/main" val="3829302584"/>
                    </a:ext>
                  </a:extLst>
                </a:gridCol>
                <a:gridCol w="820156">
                  <a:extLst>
                    <a:ext uri="{9D8B030D-6E8A-4147-A177-3AD203B41FA5}">
                      <a16:colId xmlns:a16="http://schemas.microsoft.com/office/drawing/2014/main" val="883884365"/>
                    </a:ext>
                  </a:extLst>
                </a:gridCol>
                <a:gridCol w="894716">
                  <a:extLst>
                    <a:ext uri="{9D8B030D-6E8A-4147-A177-3AD203B41FA5}">
                      <a16:colId xmlns:a16="http://schemas.microsoft.com/office/drawing/2014/main" val="2070794288"/>
                    </a:ext>
                  </a:extLst>
                </a:gridCol>
                <a:gridCol w="894716">
                  <a:extLst>
                    <a:ext uri="{9D8B030D-6E8A-4147-A177-3AD203B41FA5}">
                      <a16:colId xmlns:a16="http://schemas.microsoft.com/office/drawing/2014/main" val="1696164443"/>
                    </a:ext>
                  </a:extLst>
                </a:gridCol>
                <a:gridCol w="798853">
                  <a:extLst>
                    <a:ext uri="{9D8B030D-6E8A-4147-A177-3AD203B41FA5}">
                      <a16:colId xmlns:a16="http://schemas.microsoft.com/office/drawing/2014/main" val="3790766566"/>
                    </a:ext>
                  </a:extLst>
                </a:gridCol>
              </a:tblGrid>
              <a:tr h="767474"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RNase MRP avgid for clustering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# clusters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DB size (G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time </a:t>
                      </a:r>
                    </a:p>
                    <a:p>
                      <a:r>
                        <a:rPr lang="en-US" sz="1100" b="1" dirty="0">
                          <a:effectLst/>
                        </a:rPr>
                        <a:t>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9666694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9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1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7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3654350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>
                          <a:effectLst/>
                        </a:rPr>
                        <a:t>5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05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51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4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8588051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64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38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53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A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1578673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2.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4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7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201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777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45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5114418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4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5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722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254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89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2821202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>
                          <a:effectLst/>
                        </a:rPr>
                        <a:t>7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2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0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357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340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583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5273342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>
                          <a:effectLst/>
                        </a:rPr>
                        <a:t>7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1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4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918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907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584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239005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2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70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348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404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742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9483521"/>
                  </a:ext>
                </a:extLst>
              </a:tr>
              <a:tr h="260941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0 (all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97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81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214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833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961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487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809132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3EF97D4-4B84-4829-8565-532FD200951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702AD-38BE-C377-F7BE-782FF7EC0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69992"/>
          </a:xfrm>
        </p:spPr>
        <p:txBody>
          <a:bodyPr>
            <a:normAutofit/>
          </a:bodyPr>
          <a:lstStyle/>
          <a:p>
            <a:r>
              <a:rPr lang="en-US" sz="3600" dirty="0"/>
              <a:t>RNase MRP-based clustering for invertebrate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E888978-A2BF-DA0E-58EE-477D4374E7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8689741"/>
              </p:ext>
            </p:extLst>
          </p:nvPr>
        </p:nvGraphicFramePr>
        <p:xfrm>
          <a:off x="4336331" y="2459355"/>
          <a:ext cx="7591511" cy="2575560"/>
        </p:xfrm>
        <a:graphic>
          <a:graphicData uri="http://schemas.openxmlformats.org/drawingml/2006/table">
            <a:tbl>
              <a:tblPr/>
              <a:tblGrid>
                <a:gridCol w="940312">
                  <a:extLst>
                    <a:ext uri="{9D8B030D-6E8A-4147-A177-3AD203B41FA5}">
                      <a16:colId xmlns:a16="http://schemas.microsoft.com/office/drawing/2014/main" val="1443994622"/>
                    </a:ext>
                  </a:extLst>
                </a:gridCol>
                <a:gridCol w="733272">
                  <a:extLst>
                    <a:ext uri="{9D8B030D-6E8A-4147-A177-3AD203B41FA5}">
                      <a16:colId xmlns:a16="http://schemas.microsoft.com/office/drawing/2014/main" val="2469015909"/>
                    </a:ext>
                  </a:extLst>
                </a:gridCol>
                <a:gridCol w="845418">
                  <a:extLst>
                    <a:ext uri="{9D8B030D-6E8A-4147-A177-3AD203B41FA5}">
                      <a16:colId xmlns:a16="http://schemas.microsoft.com/office/drawing/2014/main" val="2137586762"/>
                    </a:ext>
                  </a:extLst>
                </a:gridCol>
                <a:gridCol w="845418">
                  <a:extLst>
                    <a:ext uri="{9D8B030D-6E8A-4147-A177-3AD203B41FA5}">
                      <a16:colId xmlns:a16="http://schemas.microsoft.com/office/drawing/2014/main" val="2224683362"/>
                    </a:ext>
                  </a:extLst>
                </a:gridCol>
                <a:gridCol w="759700">
                  <a:extLst>
                    <a:ext uri="{9D8B030D-6E8A-4147-A177-3AD203B41FA5}">
                      <a16:colId xmlns:a16="http://schemas.microsoft.com/office/drawing/2014/main" val="3829302584"/>
                    </a:ext>
                  </a:extLst>
                </a:gridCol>
                <a:gridCol w="931137">
                  <a:extLst>
                    <a:ext uri="{9D8B030D-6E8A-4147-A177-3AD203B41FA5}">
                      <a16:colId xmlns:a16="http://schemas.microsoft.com/office/drawing/2014/main" val="883884365"/>
                    </a:ext>
                  </a:extLst>
                </a:gridCol>
                <a:gridCol w="845418">
                  <a:extLst>
                    <a:ext uri="{9D8B030D-6E8A-4147-A177-3AD203B41FA5}">
                      <a16:colId xmlns:a16="http://schemas.microsoft.com/office/drawing/2014/main" val="2070794288"/>
                    </a:ext>
                  </a:extLst>
                </a:gridCol>
                <a:gridCol w="845418">
                  <a:extLst>
                    <a:ext uri="{9D8B030D-6E8A-4147-A177-3AD203B41FA5}">
                      <a16:colId xmlns:a16="http://schemas.microsoft.com/office/drawing/2014/main" val="1381167274"/>
                    </a:ext>
                  </a:extLst>
                </a:gridCol>
                <a:gridCol w="845418">
                  <a:extLst>
                    <a:ext uri="{9D8B030D-6E8A-4147-A177-3AD203B41FA5}">
                      <a16:colId xmlns:a16="http://schemas.microsoft.com/office/drawing/2014/main" val="4444781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RNase MRP avgid for clustering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# clusters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DB size (G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966669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.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7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6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9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365435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>
                          <a:effectLst/>
                        </a:rPr>
                        <a:t>5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2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52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45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8588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60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56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00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157867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8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7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81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595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170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28212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8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3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999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072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045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527334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0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12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495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987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205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239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0 (all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18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76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295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8704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849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487336"/>
                  </a:ext>
                </a:extLst>
              </a:tr>
            </a:tbl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1F80C4A7-AD7F-1360-B461-31B85088ED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543" y="1216682"/>
            <a:ext cx="4052727" cy="5276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21083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4EA8CE1-F55D-9D47-1657-3F7C5F5FA3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685F8D-139C-1D2B-7961-7BD400906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69992"/>
          </a:xfrm>
        </p:spPr>
        <p:txBody>
          <a:bodyPr>
            <a:normAutofit/>
          </a:bodyPr>
          <a:lstStyle/>
          <a:p>
            <a:r>
              <a:rPr lang="en-US" sz="3600" dirty="0"/>
              <a:t>RNase MRP-based clustering for vertebrat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7036377-AB8B-1FFE-C641-51139A83F7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38" y="1443202"/>
            <a:ext cx="3449583" cy="4854310"/>
          </a:xfrm>
          <a:prstGeom prst="rect">
            <a:avLst/>
          </a:prstGeom>
        </p:spPr>
      </p:pic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6886AE4-5C52-503E-BC5A-34B8F27CBA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7198993"/>
              </p:ext>
            </p:extLst>
          </p:nvPr>
        </p:nvGraphicFramePr>
        <p:xfrm>
          <a:off x="4257041" y="2709415"/>
          <a:ext cx="7701277" cy="2057400"/>
        </p:xfrm>
        <a:graphic>
          <a:graphicData uri="http://schemas.openxmlformats.org/drawingml/2006/table">
            <a:tbl>
              <a:tblPr/>
              <a:tblGrid>
                <a:gridCol w="953908">
                  <a:extLst>
                    <a:ext uri="{9D8B030D-6E8A-4147-A177-3AD203B41FA5}">
                      <a16:colId xmlns:a16="http://schemas.microsoft.com/office/drawing/2014/main" val="1443994622"/>
                    </a:ext>
                  </a:extLst>
                </a:gridCol>
                <a:gridCol w="743875">
                  <a:extLst>
                    <a:ext uri="{9D8B030D-6E8A-4147-A177-3AD203B41FA5}">
                      <a16:colId xmlns:a16="http://schemas.microsoft.com/office/drawing/2014/main" val="2469015909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2137586762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2224683362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3829302584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883884365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2070794288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1381167274"/>
                    </a:ext>
                  </a:extLst>
                </a:gridCol>
                <a:gridCol w="857642">
                  <a:extLst>
                    <a:ext uri="{9D8B030D-6E8A-4147-A177-3AD203B41FA5}">
                      <a16:colId xmlns:a16="http://schemas.microsoft.com/office/drawing/2014/main" val="4444781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RNase MRP avgid for clustering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# clusters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DB size (G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1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2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A38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time (s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effectLst/>
                        </a:rPr>
                        <a:t>U3 ncov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9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966669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6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3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13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19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7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365435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424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44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385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8588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2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588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7836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2129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157867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82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667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81488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418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0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794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9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28212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100 (all)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4231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7505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effectLst/>
                        </a:rPr>
                        <a:t>NA</a:t>
                      </a:r>
                    </a:p>
                  </a:txBody>
                  <a:tcPr marL="95250" marR="9525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487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6094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53</Words>
  <Application>Microsoft Macintosh PowerPoint</Application>
  <PresentationFormat>Widescreen</PresentationFormat>
  <Paragraphs>3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Arial</vt:lpstr>
      <vt:lpstr>Office Theme</vt:lpstr>
      <vt:lpstr>Genome clustering supplements</vt:lpstr>
      <vt:lpstr>RNase MRP-based clustering for fungi</vt:lpstr>
      <vt:lpstr>RNase MRP-based clustering for plants</vt:lpstr>
      <vt:lpstr>RNase MRP-based clustering for invertebrates</vt:lpstr>
      <vt:lpstr>RNase MRP-based clustering for vertebrat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o, William</dc:creator>
  <cp:lastModifiedBy>Gao, William</cp:lastModifiedBy>
  <cp:revision>9</cp:revision>
  <dcterms:created xsi:type="dcterms:W3CDTF">2025-03-11T20:42:15Z</dcterms:created>
  <dcterms:modified xsi:type="dcterms:W3CDTF">2025-03-11T20:57:59Z</dcterms:modified>
</cp:coreProperties>
</file>